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4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97" autoAdjust="0"/>
    <p:restoredTop sz="96433" autoAdjust="0"/>
  </p:normalViewPr>
  <p:slideViewPr>
    <p:cSldViewPr>
      <p:cViewPr varScale="1">
        <p:scale>
          <a:sx n="65" d="100"/>
          <a:sy n="65" d="100"/>
        </p:scale>
        <p:origin x="1188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467676421048702"/>
          <c:y val="5.203484335945547E-2"/>
          <c:w val="0.77785062727811749"/>
          <c:h val="0.82320174259146051"/>
        </c:manualLayout>
      </c:layout>
      <c:barChart>
        <c:barDir val="col"/>
        <c:grouping val="clustered"/>
        <c:varyColors val="0"/>
        <c:ser>
          <c:idx val="0"/>
          <c:order val="0"/>
          <c:tx>
            <c:v>Ghsrf/f</c:v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B$67,Sheet1!$D$67,Sheet1!$F$67)</c:f>
                <c:numCache>
                  <c:formatCode>General</c:formatCode>
                  <c:ptCount val="3"/>
                  <c:pt idx="0">
                    <c:v>0.19245180594401107</c:v>
                  </c:pt>
                  <c:pt idx="1">
                    <c:v>4.9363491345100145E-2</c:v>
                  </c:pt>
                  <c:pt idx="2">
                    <c:v>1.994725823543455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B$56,Sheet1!$D$56,Sheet1!$F$56)</c:f>
              <c:strCache>
                <c:ptCount val="3"/>
                <c:pt idx="0">
                  <c:v>Epididymal fat</c:v>
                </c:pt>
                <c:pt idx="1">
                  <c:v>Inguinal fat</c:v>
                </c:pt>
                <c:pt idx="2">
                  <c:v>BAT</c:v>
                </c:pt>
              </c:strCache>
            </c:strRef>
          </c:cat>
          <c:val>
            <c:numRef>
              <c:f>(Sheet1!$B$65,Sheet1!$D$65,Sheet1!$F$65)</c:f>
              <c:numCache>
                <c:formatCode>General</c:formatCode>
                <c:ptCount val="3"/>
                <c:pt idx="0">
                  <c:v>2.7652833333333331</c:v>
                </c:pt>
                <c:pt idx="1">
                  <c:v>1.5143833333333332</c:v>
                </c:pt>
                <c:pt idx="2">
                  <c:v>0.1149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63-4379-9DCB-F361D5859F40}"/>
            </c:ext>
          </c:extLst>
        </c:ser>
        <c:ser>
          <c:idx val="1"/>
          <c:order val="1"/>
          <c:tx>
            <c:v>UCP1-Cre-ER;Ghsrf/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C$67,Sheet1!$E$67,Sheet1!$G$67)</c:f>
                <c:numCache>
                  <c:formatCode>General</c:formatCode>
                  <c:ptCount val="3"/>
                  <c:pt idx="0">
                    <c:v>0.15087242458448044</c:v>
                  </c:pt>
                  <c:pt idx="1">
                    <c:v>7.523078898370833E-2</c:v>
                  </c:pt>
                  <c:pt idx="2">
                    <c:v>2.166791791258835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B$56,Sheet1!$D$56,Sheet1!$F$56)</c:f>
              <c:strCache>
                <c:ptCount val="3"/>
                <c:pt idx="0">
                  <c:v>Epididymal fat</c:v>
                </c:pt>
                <c:pt idx="1">
                  <c:v>Inguinal fat</c:v>
                </c:pt>
                <c:pt idx="2">
                  <c:v>BAT</c:v>
                </c:pt>
              </c:strCache>
            </c:strRef>
          </c:cat>
          <c:val>
            <c:numRef>
              <c:f>(Sheet1!$C$65,Sheet1!$E$65,Sheet1!$G$65)</c:f>
              <c:numCache>
                <c:formatCode>General</c:formatCode>
                <c:ptCount val="3"/>
                <c:pt idx="0">
                  <c:v>2.8886500000000002</c:v>
                </c:pt>
                <c:pt idx="1">
                  <c:v>1.5935833333333331</c:v>
                </c:pt>
                <c:pt idx="2">
                  <c:v>0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63-4379-9DCB-F361D5859F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530240"/>
        <c:axId val="346524360"/>
      </c:barChart>
      <c:catAx>
        <c:axId val="346530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6524360"/>
        <c:crosses val="autoZero"/>
        <c:auto val="1"/>
        <c:lblAlgn val="ctr"/>
        <c:lblOffset val="100"/>
        <c:noMultiLvlLbl val="0"/>
      </c:catAx>
      <c:valAx>
        <c:axId val="3465243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</a:rPr>
                  <a:t>Tissue weight (g)</a:t>
                </a:r>
              </a:p>
            </c:rich>
          </c:tx>
          <c:layout>
            <c:manualLayout>
              <c:xMode val="edge"/>
              <c:yMode val="edge"/>
              <c:x val="1.4985059188033978E-2"/>
              <c:y val="0.2379970724899051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6530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5F30F1-3238-4BD6-949C-5AA592CFF731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D382EE-099F-42CC-91CF-A8EA3A6B83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634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A8833DE-1480-4DDB-AD9B-68991A8CBD2C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0174BBB-F138-4932-B651-BAB7CFAC2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184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174BBB-F138-4932-B651-BAB7CFAC2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716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339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609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21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482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579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54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726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481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614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891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911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6D5BD-8824-47C6-B725-729D0EBB4FCA}" type="datetimeFigureOut">
              <a:rPr lang="en-US" smtClean="0"/>
              <a:t>3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8E940-B2D7-4772-8EBE-BF56A407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800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787210" y="304800"/>
            <a:ext cx="6558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</a:t>
            </a:r>
            <a:r>
              <a:rPr lang="en-US" b="1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1 Fig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0377245"/>
              </p:ext>
            </p:extLst>
          </p:nvPr>
        </p:nvGraphicFramePr>
        <p:xfrm>
          <a:off x="1523999" y="961318"/>
          <a:ext cx="5085065" cy="33058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8" name="Group 27"/>
          <p:cNvGrpSpPr/>
          <p:nvPr/>
        </p:nvGrpSpPr>
        <p:grpSpPr>
          <a:xfrm>
            <a:off x="4876800" y="1143000"/>
            <a:ext cx="1662671" cy="796279"/>
            <a:chOff x="6227843" y="459936"/>
            <a:chExt cx="1374920" cy="796279"/>
          </a:xfrm>
        </p:grpSpPr>
        <p:sp>
          <p:nvSpPr>
            <p:cNvPr id="29" name="Rectangle 28"/>
            <p:cNvSpPr/>
            <p:nvPr/>
          </p:nvSpPr>
          <p:spPr>
            <a:xfrm>
              <a:off x="6227843" y="590741"/>
              <a:ext cx="76200" cy="762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304043" y="459936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err="1"/>
                <a:t>Ghsr</a:t>
              </a:r>
              <a:r>
                <a:rPr lang="en-US" sz="1400" b="1" i="1" baseline="30000" dirty="0" err="1"/>
                <a:t>f</a:t>
              </a:r>
              <a:r>
                <a:rPr lang="en-US" sz="1400" b="1" i="1" baseline="30000" dirty="0"/>
                <a:t>/f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6227847" y="840936"/>
              <a:ext cx="76200" cy="76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281806" y="732995"/>
              <a:ext cx="132095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/>
                <a:t>UCP1</a:t>
              </a:r>
              <a:r>
                <a:rPr lang="en-US" sz="1400" b="1" dirty="0"/>
                <a:t>-Cre</a:t>
              </a:r>
              <a:r>
                <a:rPr lang="en-US" sz="1400" b="1" baseline="30000" dirty="0"/>
                <a:t>ER</a:t>
              </a:r>
              <a:r>
                <a:rPr lang="en-US" sz="1400" b="1" dirty="0"/>
                <a:t>/</a:t>
              </a:r>
              <a:r>
                <a:rPr lang="en-US" sz="1400" b="1" i="1" dirty="0" err="1"/>
                <a:t>Ghsr</a:t>
              </a:r>
              <a:r>
                <a:rPr lang="en-US" sz="1400" b="1" i="1" baseline="30000" dirty="0" err="1"/>
                <a:t>f</a:t>
              </a:r>
              <a:r>
                <a:rPr lang="en-US" sz="1400" b="1" i="1" baseline="30000" dirty="0"/>
                <a:t>/f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459F261-57D9-49B2-A80F-4AD1BBBB0402}"/>
              </a:ext>
            </a:extLst>
          </p:cNvPr>
          <p:cNvSpPr txBox="1"/>
          <p:nvPr/>
        </p:nvSpPr>
        <p:spPr>
          <a:xfrm>
            <a:off x="1219200" y="4517067"/>
            <a:ext cx="61266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eight of different fat deports of HFD-fed mice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0-week old male 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sr</a:t>
            </a:r>
            <a:r>
              <a:rPr lang="en-US" sz="1200" i="1" baseline="30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CP1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Cre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sr</a:t>
            </a:r>
            <a:r>
              <a:rPr lang="en-US" sz="1200" i="1" baseline="30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ce fed HFD.  The weights of epididymal fat, inguinal fat and BAT at termination of the experiment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All data were expressed as the mean </a:t>
            </a:r>
            <a:r>
              <a:rPr lang="en-US" sz="12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± SEM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n = 3‒6, *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, 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sr</a:t>
            </a:r>
            <a:r>
              <a:rPr lang="en-US" sz="1200" i="1" baseline="30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CP1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Cre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sr</a:t>
            </a:r>
            <a:r>
              <a:rPr lang="en-US" sz="1200" i="1" baseline="30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f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6201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90</TotalTime>
  <Words>8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CP-1 paper</dc:title>
  <dc:creator>Kanikarla Marie, Preeti</dc:creator>
  <cp:lastModifiedBy>chn off35</cp:lastModifiedBy>
  <cp:revision>260</cp:revision>
  <cp:lastPrinted>2016-04-22T19:34:24Z</cp:lastPrinted>
  <dcterms:created xsi:type="dcterms:W3CDTF">2015-12-22T22:01:29Z</dcterms:created>
  <dcterms:modified xsi:type="dcterms:W3CDTF">2021-03-25T09:40:33Z</dcterms:modified>
</cp:coreProperties>
</file>